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7" r:id="rId3"/>
    <p:sldId id="269" r:id="rId4"/>
    <p:sldId id="270" r:id="rId5"/>
    <p:sldId id="271" r:id="rId6"/>
    <p:sldId id="272" r:id="rId7"/>
    <p:sldId id="256" r:id="rId8"/>
    <p:sldId id="257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14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E7E52B-7169-4500-8395-70E445FAB8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F5DE2D-3F17-4E41-BEF6-84679E1A8D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839595-95F6-4424-9687-2228A1CC6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A4791D-7CB8-462E-9336-A1EB627AA6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359FEA-0C80-4716-B623-1D6B3519C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65093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2335A-F588-416D-A73D-EFFF62FE0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E121B3-C75E-40B0-BFB3-BB192C2702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2F119E-6077-44BF-9ECD-D0827E19D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070F8C-F671-4E8D-8BC6-E563501BB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D711D7-CE9B-4400-8378-60BB29B68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5386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2640703-0D49-4C14-979D-2478FE1903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6D9ADF-1934-4428-B707-295EA6019E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E6277E-E34B-4F56-9AD2-0A059A3F0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35414D-A616-4E8F-B8CA-13F8BE991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445D47-4DFE-488A-90C7-32A031A08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83817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8226A2-1FAC-40F9-9662-78EE801F3E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7397DC-BAFF-4FF6-8B22-D3F7C77D07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94479-CA5B-4F99-81E6-2079FF4F5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B1A692-65B0-4391-B28D-5A25B79EF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264FB4-7DD9-4688-B6A5-F7BE4D059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86998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4432F-9240-4452-B214-114187771C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C307B4-C58B-4907-925E-26CCBCB890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2EA81C-9715-4DF9-AD02-A625D2D76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080ED8-8F18-407A-A205-B39988413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570B51-4F74-4750-B16F-B110C672A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79457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3C209-6D54-4F8F-AC92-C0F01ECE76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36F645-8F7E-4A3E-878D-0593BB4C3B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A4EC67-C00B-4B83-8C38-5609AFD6D9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1C35D2-FF57-4144-854C-AE8AD03D27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58D150-9F12-4E7B-8C20-9094EB08C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9925E4-5B19-40A3-A216-3082BDC468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58979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61042E-461C-4E93-BEEB-65BDC8FBE9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9AFAF8-AD5B-40D9-BA03-3DA57E50AF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2356C6-4BD6-46F2-8EBE-8BD513044B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57058F-1FF8-40C9-A2C7-7AE5488582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206440A-82E9-4832-985B-EA39B5C71C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ED5300-1F78-4E3F-888E-088A64292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C90F02-67F4-4BDD-B8C7-EC438CF9A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918CD1-7967-4083-8A61-9F299B6D7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99080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3A9F9F-6CB4-40B2-9DF3-E04073550C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78408B-A65E-4AE0-8032-34EE76C93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4413E6-68B3-4164-9AC8-5A7617EE4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F3F88F-C8F6-4F29-B5C1-EEFBC49A0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4926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68B6D0E-6182-4A19-8E3B-78DEDB142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C1F965-C42E-4491-B256-9C3E4132F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D9E066-F9AF-4CD4-93E4-A429A28CA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60868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290FA1-6318-42D2-A404-D9E9DCDAD0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0B1C58-EC0B-490F-A53F-AB1BAA83BF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0E40B7-621D-4292-95B5-D7F4595E11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176E9D-F94F-4796-8F12-2D0D5DA2D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25445E-D9D0-4167-AC8F-AC90F3134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3476A6-1980-445D-901A-81A8C3482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83365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8AD847-1A26-4A15-954C-03553B02B7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8A708F-3660-49B5-AFFC-1778D4167A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56370E-4665-4220-8F6C-2FBDD221E3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50CF3E-E39C-46D3-B197-867315D15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8A16AA-7F7F-46ED-85E4-CCC6E66C1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5987D2-0F1F-41C5-B42A-26F04FA90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85026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7A3DD6-27C6-4F85-A807-6893F47AAE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472A5C-C8DC-4107-8F3D-BB9DBE23FF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DDC651-A39E-4548-9CAE-E6F3760190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507476-F65E-437E-B53E-EFDF7711EA8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92002D-ED79-4E85-846C-C2E4E6956D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C0D2FE-5340-4CAC-B1A4-42256902B1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9335DC-F5E1-41D2-8D71-34C86BB819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1120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3102F67-727A-4F93-8964-E698C924AF89}"/>
              </a:ext>
            </a:extLst>
          </p:cNvPr>
          <p:cNvSpPr txBox="1"/>
          <p:nvPr/>
        </p:nvSpPr>
        <p:spPr>
          <a:xfrm>
            <a:off x="3911600" y="369053"/>
            <a:ext cx="13817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A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DF2D2B8-23F3-45BC-BC69-600EAA64EB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46711" y="1579880"/>
            <a:ext cx="7663378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55AC7DF-96AD-4E8C-9E38-D90326DBC348}"/>
              </a:ext>
            </a:extLst>
          </p:cNvPr>
          <p:cNvSpPr txBox="1"/>
          <p:nvPr/>
        </p:nvSpPr>
        <p:spPr>
          <a:xfrm>
            <a:off x="2783840" y="3525520"/>
            <a:ext cx="2519680" cy="68072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4909B9D-2914-4AC0-85CE-2856038CF637}"/>
              </a:ext>
            </a:extLst>
          </p:cNvPr>
          <p:cNvSpPr txBox="1"/>
          <p:nvPr/>
        </p:nvSpPr>
        <p:spPr>
          <a:xfrm>
            <a:off x="2123440" y="3649821"/>
            <a:ext cx="7416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NICD</a:t>
            </a:r>
          </a:p>
        </p:txBody>
      </p:sp>
    </p:spTree>
    <p:extLst>
      <p:ext uri="{BB962C8B-B14F-4D97-AF65-F5344CB8AC3E}">
        <p14:creationId xmlns:p14="http://schemas.microsoft.com/office/powerpoint/2010/main" val="32820096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3102F67-727A-4F93-8964-E698C924AF89}"/>
              </a:ext>
            </a:extLst>
          </p:cNvPr>
          <p:cNvSpPr txBox="1"/>
          <p:nvPr/>
        </p:nvSpPr>
        <p:spPr>
          <a:xfrm>
            <a:off x="3769360" y="369054"/>
            <a:ext cx="14325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A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9DDA55C8-B203-40CC-83ED-D101AA120CC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854392" y="1688941"/>
            <a:ext cx="8105775" cy="396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6C75A55-3622-46B6-BE1C-E3FC5E51E4C7}"/>
              </a:ext>
            </a:extLst>
          </p:cNvPr>
          <p:cNvSpPr txBox="1"/>
          <p:nvPr/>
        </p:nvSpPr>
        <p:spPr>
          <a:xfrm>
            <a:off x="2235200" y="3302000"/>
            <a:ext cx="2905760" cy="75184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13AE943-B26F-4017-8F5B-007542FDEE62}"/>
              </a:ext>
            </a:extLst>
          </p:cNvPr>
          <p:cNvSpPr txBox="1"/>
          <p:nvPr/>
        </p:nvSpPr>
        <p:spPr>
          <a:xfrm>
            <a:off x="1310640" y="3525520"/>
            <a:ext cx="7365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8079725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7A68B17-5162-419F-91CC-BEEC82CC6FC9}"/>
              </a:ext>
            </a:extLst>
          </p:cNvPr>
          <p:cNvSpPr txBox="1"/>
          <p:nvPr/>
        </p:nvSpPr>
        <p:spPr>
          <a:xfrm>
            <a:off x="3688080" y="325120"/>
            <a:ext cx="15443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C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2">
            <a:extLst>
              <a:ext uri="{FF2B5EF4-FFF2-40B4-BE49-F238E27FC236}">
                <a16:creationId xmlns:a16="http://schemas.microsoft.com/office/drawing/2014/main" id="{172EF8AA-973C-4E38-89B7-EBBFAEF37ED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 l="31325" t="60703" r="33012" b="22684"/>
          <a:stretch>
            <a:fillRect/>
          </a:stretch>
        </p:blipFill>
        <p:spPr bwMode="auto">
          <a:xfrm>
            <a:off x="1330960" y="1879600"/>
            <a:ext cx="7465500" cy="284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08CAB1D-A19C-4635-BA44-A33CFB06C2B7}"/>
              </a:ext>
            </a:extLst>
          </p:cNvPr>
          <p:cNvSpPr txBox="1"/>
          <p:nvPr/>
        </p:nvSpPr>
        <p:spPr>
          <a:xfrm>
            <a:off x="1330960" y="3429000"/>
            <a:ext cx="7465500" cy="94996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3133EB3-F563-49E9-ADD0-F54CA7E6D4DE}"/>
              </a:ext>
            </a:extLst>
          </p:cNvPr>
          <p:cNvSpPr txBox="1"/>
          <p:nvPr/>
        </p:nvSpPr>
        <p:spPr>
          <a:xfrm>
            <a:off x="703140" y="3799840"/>
            <a:ext cx="820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NICD</a:t>
            </a:r>
          </a:p>
        </p:txBody>
      </p:sp>
    </p:spTree>
    <p:extLst>
      <p:ext uri="{BB962C8B-B14F-4D97-AF65-F5344CB8AC3E}">
        <p14:creationId xmlns:p14="http://schemas.microsoft.com/office/powerpoint/2010/main" val="27724974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7A68B17-5162-419F-91CC-BEEC82CC6FC9}"/>
              </a:ext>
            </a:extLst>
          </p:cNvPr>
          <p:cNvSpPr txBox="1"/>
          <p:nvPr/>
        </p:nvSpPr>
        <p:spPr>
          <a:xfrm>
            <a:off x="3789680" y="325120"/>
            <a:ext cx="14020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C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A0317021-16CA-47AE-9FE9-3ADACA44CC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 l="32289" t="58786" r="31566" b="23962"/>
          <a:stretch>
            <a:fillRect/>
          </a:stretch>
        </p:blipFill>
        <p:spPr bwMode="auto">
          <a:xfrm>
            <a:off x="1432560" y="1894840"/>
            <a:ext cx="7465500" cy="284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D9E2AD4-940A-45FF-972F-B5ECEDB2152B}"/>
              </a:ext>
            </a:extLst>
          </p:cNvPr>
          <p:cNvSpPr txBox="1"/>
          <p:nvPr/>
        </p:nvSpPr>
        <p:spPr>
          <a:xfrm>
            <a:off x="1503680" y="2590800"/>
            <a:ext cx="7394380" cy="127000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BB19497-62AF-4688-8737-C7980E73066D}"/>
              </a:ext>
            </a:extLst>
          </p:cNvPr>
          <p:cNvSpPr txBox="1"/>
          <p:nvPr/>
        </p:nvSpPr>
        <p:spPr>
          <a:xfrm>
            <a:off x="822961" y="2987040"/>
            <a:ext cx="6908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18054848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BB5BD81-E4F1-47E0-BED4-296984BED948}"/>
              </a:ext>
            </a:extLst>
          </p:cNvPr>
          <p:cNvSpPr txBox="1"/>
          <p:nvPr/>
        </p:nvSpPr>
        <p:spPr>
          <a:xfrm>
            <a:off x="4043680" y="257294"/>
            <a:ext cx="13817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D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01CFE7E9-E861-4A3D-AF48-0011DB567E7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 l="34217" t="61342" r="30120" b="22684"/>
          <a:stretch>
            <a:fillRect/>
          </a:stretch>
        </p:blipFill>
        <p:spPr bwMode="auto">
          <a:xfrm>
            <a:off x="1056640" y="1818640"/>
            <a:ext cx="7654500" cy="29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561E126-4B38-41AF-9853-0A5BC37F4A7D}"/>
              </a:ext>
            </a:extLst>
          </p:cNvPr>
          <p:cNvSpPr txBox="1"/>
          <p:nvPr/>
        </p:nvSpPr>
        <p:spPr>
          <a:xfrm>
            <a:off x="1056640" y="3241040"/>
            <a:ext cx="7654500" cy="133096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47B275F-D216-4909-8C0A-14E54B8E32B9}"/>
              </a:ext>
            </a:extLst>
          </p:cNvPr>
          <p:cNvSpPr txBox="1"/>
          <p:nvPr/>
        </p:nvSpPr>
        <p:spPr>
          <a:xfrm>
            <a:off x="436880" y="3677920"/>
            <a:ext cx="7416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NICD</a:t>
            </a:r>
          </a:p>
        </p:txBody>
      </p:sp>
    </p:spTree>
    <p:extLst>
      <p:ext uri="{BB962C8B-B14F-4D97-AF65-F5344CB8AC3E}">
        <p14:creationId xmlns:p14="http://schemas.microsoft.com/office/powerpoint/2010/main" val="32340695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08F3B1B0-9E14-433E-B3D1-167CFF26AD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 l="27470" t="57508" r="36385" b="27157"/>
          <a:stretch>
            <a:fillRect/>
          </a:stretch>
        </p:blipFill>
        <p:spPr bwMode="auto">
          <a:xfrm>
            <a:off x="1117600" y="2219960"/>
            <a:ext cx="7654500" cy="29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2DE5421-322D-4439-A640-8BD5DEE64408}"/>
              </a:ext>
            </a:extLst>
          </p:cNvPr>
          <p:cNvSpPr txBox="1"/>
          <p:nvPr/>
        </p:nvSpPr>
        <p:spPr>
          <a:xfrm>
            <a:off x="4033520" y="470654"/>
            <a:ext cx="1381760" cy="3827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D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1A38ABD-5A48-445F-B9E0-B57EFBF15D03}"/>
              </a:ext>
            </a:extLst>
          </p:cNvPr>
          <p:cNvSpPr txBox="1"/>
          <p:nvPr/>
        </p:nvSpPr>
        <p:spPr>
          <a:xfrm>
            <a:off x="538480" y="3647440"/>
            <a:ext cx="7061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/>
              <a:t>Act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D0773F0-9BD0-4499-916A-BB7592115148}"/>
              </a:ext>
            </a:extLst>
          </p:cNvPr>
          <p:cNvSpPr txBox="1"/>
          <p:nvPr/>
        </p:nvSpPr>
        <p:spPr>
          <a:xfrm>
            <a:off x="1244599" y="3078480"/>
            <a:ext cx="7527501" cy="127000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3088680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7B253251-EB7B-4642-B9F8-6020E017A79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348124" y="1325880"/>
            <a:ext cx="7218901" cy="45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E108989-C519-423C-A532-2BEBD65ECCF1}"/>
              </a:ext>
            </a:extLst>
          </p:cNvPr>
          <p:cNvSpPr txBox="1"/>
          <p:nvPr/>
        </p:nvSpPr>
        <p:spPr>
          <a:xfrm>
            <a:off x="2255520" y="2174240"/>
            <a:ext cx="2804160" cy="84328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BFC93BD-ED36-47D0-A4FB-756F68BB0ACA}"/>
              </a:ext>
            </a:extLst>
          </p:cNvPr>
          <p:cNvSpPr txBox="1"/>
          <p:nvPr/>
        </p:nvSpPr>
        <p:spPr>
          <a:xfrm>
            <a:off x="1635760" y="2397760"/>
            <a:ext cx="7823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ICD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90FDCE-6923-4B87-8768-174AE5CD8C88}"/>
              </a:ext>
            </a:extLst>
          </p:cNvPr>
          <p:cNvSpPr txBox="1"/>
          <p:nvPr/>
        </p:nvSpPr>
        <p:spPr>
          <a:xfrm>
            <a:off x="3921760" y="447040"/>
            <a:ext cx="13919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E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18052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B8BB0B90-AA88-43CD-94B3-2A0C620F201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256249" y="1132840"/>
            <a:ext cx="7421801" cy="45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8AB65E7-23C0-45A9-97CE-09AF7017B17E}"/>
              </a:ext>
            </a:extLst>
          </p:cNvPr>
          <p:cNvSpPr txBox="1"/>
          <p:nvPr/>
        </p:nvSpPr>
        <p:spPr>
          <a:xfrm>
            <a:off x="1270000" y="4419601"/>
            <a:ext cx="7213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AFFEC18-8A3C-4432-A729-066125AE17FD}"/>
              </a:ext>
            </a:extLst>
          </p:cNvPr>
          <p:cNvSpPr txBox="1"/>
          <p:nvPr/>
        </p:nvSpPr>
        <p:spPr>
          <a:xfrm>
            <a:off x="2092960" y="4196080"/>
            <a:ext cx="3078480" cy="97536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99EF4F5-2BEE-4747-A79B-4056825E2F69}"/>
              </a:ext>
            </a:extLst>
          </p:cNvPr>
          <p:cNvSpPr txBox="1"/>
          <p:nvPr/>
        </p:nvSpPr>
        <p:spPr>
          <a:xfrm>
            <a:off x="4104640" y="397120"/>
            <a:ext cx="15138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E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9581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4</Words>
  <Application>Microsoft Office PowerPoint</Application>
  <PresentationFormat>On-screen Show (4:3)</PresentationFormat>
  <Paragraphs>16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Sushil chaurasia</dc:creator>
  <cp:lastModifiedBy>Dr Sushil chaurasia</cp:lastModifiedBy>
  <cp:revision>10</cp:revision>
  <dcterms:created xsi:type="dcterms:W3CDTF">2022-05-03T13:22:03Z</dcterms:created>
  <dcterms:modified xsi:type="dcterms:W3CDTF">2022-08-08T20:41:11Z</dcterms:modified>
</cp:coreProperties>
</file>